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3"/>
    <p:restoredTop sz="94693"/>
  </p:normalViewPr>
  <p:slideViewPr>
    <p:cSldViewPr snapToGrid="0" snapToObjects="1">
      <p:cViewPr varScale="1">
        <p:scale>
          <a:sx n="78" d="100"/>
          <a:sy n="78" d="100"/>
        </p:scale>
        <p:origin x="2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061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87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440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98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686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19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4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488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18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390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154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98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Users\Angela\Documents\NYC\Sussel Lab\EPKO\EPKO Paper Figures\Supp Table 6_Page_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3" t="7597" r="65909" b="9069"/>
          <a:stretch/>
        </p:blipFill>
        <p:spPr bwMode="auto">
          <a:xfrm>
            <a:off x="566195" y="1381246"/>
            <a:ext cx="2876550" cy="6477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C:\Users\Angela\Documents\NYC\Sussel Lab\EPKO\EPKO Paper Figures\Supp Table 6_Page_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2" t="7598" r="65140" b="55883"/>
          <a:stretch/>
        </p:blipFill>
        <p:spPr bwMode="auto">
          <a:xfrm>
            <a:off x="3442745" y="1781296"/>
            <a:ext cx="2934833" cy="2838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569026" y="337530"/>
            <a:ext cx="525303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1C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300" baseline="30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E15.5 RNA-</a:t>
            </a:r>
            <a:r>
              <a:rPr lang="en-US" sz="13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- Genes showing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ly differential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xpression in only Nkx2.2</a:t>
            </a:r>
            <a:r>
              <a:rPr lang="en-US" sz="1300" baseline="30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mice (55 genes)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56658" y="679144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1472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7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Symbo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6-08-03T22:46:02Z</dcterms:created>
  <dcterms:modified xsi:type="dcterms:W3CDTF">2016-08-04T16:56:31Z</dcterms:modified>
</cp:coreProperties>
</file>